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2" r:id="rId3"/>
    <p:sldId id="266" r:id="rId4"/>
    <p:sldId id="268" r:id="rId5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  <a:srgbClr val="FF3300"/>
    <a:srgbClr val="FF9933"/>
    <a:srgbClr val="FF9900"/>
    <a:srgbClr val="FFCC00"/>
    <a:srgbClr val="CCFFCC"/>
    <a:srgbClr val="006600"/>
    <a:srgbClr val="00CC00"/>
    <a:srgbClr val="33CC33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7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3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758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3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4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876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177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783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709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151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93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413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7B5DE-0528-4299-A44B-09AE00AF54CF}" type="datetimeFigureOut">
              <a:rPr lang="en-US" smtClean="0"/>
              <a:t>1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8AEC5-D7A4-40E7-8A09-7673E40AE6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713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9955988"/>
              </p:ext>
            </p:extLst>
          </p:nvPr>
        </p:nvGraphicFramePr>
        <p:xfrm>
          <a:off x="76201" y="304801"/>
          <a:ext cx="9725025" cy="4090111"/>
        </p:xfrm>
        <a:graphic>
          <a:graphicData uri="http://schemas.openxmlformats.org/drawingml/2006/table">
            <a:tbl>
              <a:tblPr/>
              <a:tblGrid>
                <a:gridCol w="313763">
                  <a:extLst>
                    <a:ext uri="{9D8B030D-6E8A-4147-A177-3AD203B41FA5}">
                      <a16:colId xmlns:a16="http://schemas.microsoft.com/office/drawing/2014/main" val="2495557910"/>
                    </a:ext>
                  </a:extLst>
                </a:gridCol>
                <a:gridCol w="1054048">
                  <a:extLst>
                    <a:ext uri="{9D8B030D-6E8A-4147-A177-3AD203B41FA5}">
                      <a16:colId xmlns:a16="http://schemas.microsoft.com/office/drawing/2014/main" val="4272568511"/>
                    </a:ext>
                  </a:extLst>
                </a:gridCol>
                <a:gridCol w="627526">
                  <a:extLst>
                    <a:ext uri="{9D8B030D-6E8A-4147-A177-3AD203B41FA5}">
                      <a16:colId xmlns:a16="http://schemas.microsoft.com/office/drawing/2014/main" val="3461187515"/>
                    </a:ext>
                  </a:extLst>
                </a:gridCol>
                <a:gridCol w="856312">
                  <a:extLst>
                    <a:ext uri="{9D8B030D-6E8A-4147-A177-3AD203B41FA5}">
                      <a16:colId xmlns:a16="http://schemas.microsoft.com/office/drawing/2014/main" val="4017901629"/>
                    </a:ext>
                  </a:extLst>
                </a:gridCol>
                <a:gridCol w="777871">
                  <a:extLst>
                    <a:ext uri="{9D8B030D-6E8A-4147-A177-3AD203B41FA5}">
                      <a16:colId xmlns:a16="http://schemas.microsoft.com/office/drawing/2014/main" val="2934520006"/>
                    </a:ext>
                  </a:extLst>
                </a:gridCol>
                <a:gridCol w="1045878">
                  <a:extLst>
                    <a:ext uri="{9D8B030D-6E8A-4147-A177-3AD203B41FA5}">
                      <a16:colId xmlns:a16="http://schemas.microsoft.com/office/drawing/2014/main" val="3639992162"/>
                    </a:ext>
                  </a:extLst>
                </a:gridCol>
                <a:gridCol w="916777">
                  <a:extLst>
                    <a:ext uri="{9D8B030D-6E8A-4147-A177-3AD203B41FA5}">
                      <a16:colId xmlns:a16="http://schemas.microsoft.com/office/drawing/2014/main" val="3211511509"/>
                    </a:ext>
                  </a:extLst>
                </a:gridCol>
                <a:gridCol w="751725">
                  <a:extLst>
                    <a:ext uri="{9D8B030D-6E8A-4147-A177-3AD203B41FA5}">
                      <a16:colId xmlns:a16="http://schemas.microsoft.com/office/drawing/2014/main" val="2843149943"/>
                    </a:ext>
                  </a:extLst>
                </a:gridCol>
                <a:gridCol w="830165">
                  <a:extLst>
                    <a:ext uri="{9D8B030D-6E8A-4147-A177-3AD203B41FA5}">
                      <a16:colId xmlns:a16="http://schemas.microsoft.com/office/drawing/2014/main" val="3478717691"/>
                    </a:ext>
                  </a:extLst>
                </a:gridCol>
                <a:gridCol w="536013">
                  <a:extLst>
                    <a:ext uri="{9D8B030D-6E8A-4147-A177-3AD203B41FA5}">
                      <a16:colId xmlns:a16="http://schemas.microsoft.com/office/drawing/2014/main" val="1635029119"/>
                    </a:ext>
                  </a:extLst>
                </a:gridCol>
                <a:gridCol w="516402">
                  <a:extLst>
                    <a:ext uri="{9D8B030D-6E8A-4147-A177-3AD203B41FA5}">
                      <a16:colId xmlns:a16="http://schemas.microsoft.com/office/drawing/2014/main" val="1576475699"/>
                    </a:ext>
                  </a:extLst>
                </a:gridCol>
                <a:gridCol w="503328">
                  <a:extLst>
                    <a:ext uri="{9D8B030D-6E8A-4147-A177-3AD203B41FA5}">
                      <a16:colId xmlns:a16="http://schemas.microsoft.com/office/drawing/2014/main" val="1889022396"/>
                    </a:ext>
                  </a:extLst>
                </a:gridCol>
                <a:gridCol w="995217">
                  <a:extLst>
                    <a:ext uri="{9D8B030D-6E8A-4147-A177-3AD203B41FA5}">
                      <a16:colId xmlns:a16="http://schemas.microsoft.com/office/drawing/2014/main" val="280690425"/>
                    </a:ext>
                  </a:extLst>
                </a:gridCol>
              </a:tblGrid>
              <a:tr h="1745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7337192"/>
                  </a:ext>
                </a:extLst>
              </a:tr>
              <a:tr h="34433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ter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ween 80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-Acetyl-D-Galactosam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-Acetyl-D-Glucosam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-Acetyl-D-Mannosam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on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ygdali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Arabi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rabi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Arab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buti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Cellobi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3208087"/>
                  </a:ext>
                </a:extLst>
              </a:tr>
              <a:tr h="51409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odextr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odextri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xtri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-Erythr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Fruc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Fuc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alac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alacturo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tiobi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luco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lucosam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luc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589510"/>
                  </a:ext>
                </a:extLst>
              </a:tr>
              <a:tr h="34433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-1-Phosphat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uronam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lucuro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ge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-Inos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Keto-D-Gluco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Lac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ul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t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totrio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3612070"/>
                  </a:ext>
                </a:extLst>
              </a:tr>
              <a:tr h="34433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ann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an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elezi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elibi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-D-Galactos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-D-Galactos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-D-Glucos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-D-Glucos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lati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Psic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Raffi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Rham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1045193"/>
                  </a:ext>
                </a:extLst>
              </a:tr>
              <a:tr h="34433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Rib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lici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edoheptulosan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Sorb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Sorb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chy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r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Tagat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470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Trehal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ran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ylit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8A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Xylos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3072259"/>
                  </a:ext>
                </a:extLst>
              </a:tr>
              <a:tr h="51409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-buty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omo succi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969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ma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-buty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969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-buty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969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Hydroxy phenylacet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to-gluta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Lactic Acid Methyl Ester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Lact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al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Mal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ini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9472233"/>
                  </a:ext>
                </a:extLst>
              </a:tr>
              <a:tr h="51409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Sacchar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bac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cinam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cin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ccinic Acid Mono-Methyl Ester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-Acetly-L-Glutam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ninamid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D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lan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lanyl-Glyc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sparag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spart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Glutam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3706515"/>
                  </a:ext>
                </a:extLst>
              </a:tr>
              <a:tr h="34433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yl-L-Glutam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Ornith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Phenylalan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Prol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Pyroglutamic Acid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Ser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Threon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Amino Ethanol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tresc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s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idin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enosine-5'-Monophosphate</a:t>
                      </a:r>
                    </a:p>
                  </a:txBody>
                  <a:tcPr marL="4309" marR="4309" marT="43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F8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846920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5503809"/>
              </p:ext>
            </p:extLst>
          </p:nvPr>
        </p:nvGraphicFramePr>
        <p:xfrm>
          <a:off x="580809" y="4554243"/>
          <a:ext cx="3833728" cy="1539240"/>
        </p:xfrm>
        <a:graphic>
          <a:graphicData uri="http://schemas.openxmlformats.org/drawingml/2006/table">
            <a:tbl>
              <a:tblPr/>
              <a:tblGrid>
                <a:gridCol w="2403066">
                  <a:extLst>
                    <a:ext uri="{9D8B030D-6E8A-4147-A177-3AD203B41FA5}">
                      <a16:colId xmlns:a16="http://schemas.microsoft.com/office/drawing/2014/main" val="2446944687"/>
                    </a:ext>
                  </a:extLst>
                </a:gridCol>
                <a:gridCol w="1430662">
                  <a:extLst>
                    <a:ext uri="{9D8B030D-6E8A-4147-A177-3AD203B41FA5}">
                      <a16:colId xmlns:a16="http://schemas.microsoft.com/office/drawing/2014/main" val="26392344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gen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99537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F8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88209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saccharid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00372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ge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nd heterocyclic amin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94113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id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16740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ol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8A5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38372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iphatic organic aci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969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92996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 Aci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2226872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6306370"/>
              </p:ext>
            </p:extLst>
          </p:nvPr>
        </p:nvGraphicFramePr>
        <p:xfrm>
          <a:off x="5907206" y="4458040"/>
          <a:ext cx="3263900" cy="1731645"/>
        </p:xfrm>
        <a:graphic>
          <a:graphicData uri="http://schemas.openxmlformats.org/drawingml/2006/table">
            <a:tbl>
              <a:tblPr/>
              <a:tblGrid>
                <a:gridCol w="2045885">
                  <a:extLst>
                    <a:ext uri="{9D8B030D-6E8A-4147-A177-3AD203B41FA5}">
                      <a16:colId xmlns:a16="http://schemas.microsoft.com/office/drawing/2014/main" val="2446944687"/>
                    </a:ext>
                  </a:extLst>
                </a:gridCol>
                <a:gridCol w="1218015">
                  <a:extLst>
                    <a:ext uri="{9D8B030D-6E8A-4147-A177-3AD203B41FA5}">
                      <a16:colId xmlns:a16="http://schemas.microsoft.com/office/drawing/2014/main" val="26392344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gen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99537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A-cycle intermediat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A0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23638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gar aci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7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87084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pto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93576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igosaccharid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41830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samin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95398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470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17628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ntos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50943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543697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6235058"/>
            <a:ext cx="9905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ure S1</a:t>
            </a:r>
            <a:r>
              <a:rPr lang="en-US" dirty="0"/>
              <a:t>. Categorization of 95 carbon sources FF </a:t>
            </a:r>
            <a:r>
              <a:rPr lang="en-US" dirty="0" err="1"/>
              <a:t>MicroPlate</a:t>
            </a:r>
            <a:r>
              <a:rPr lang="en-US" dirty="0"/>
              <a:t>™ based on </a:t>
            </a:r>
          </a:p>
          <a:p>
            <a:pPr algn="ctr"/>
            <a:r>
              <a:rPr lang="en-US" dirty="0" err="1"/>
              <a:t>Atanasova</a:t>
            </a:r>
            <a:r>
              <a:rPr lang="en-US" dirty="0"/>
              <a:t> and </a:t>
            </a:r>
            <a:r>
              <a:rPr lang="en-US" dirty="0" err="1"/>
              <a:t>Druzhinina</a:t>
            </a:r>
            <a:r>
              <a:rPr lang="en-US" dirty="0"/>
              <a:t>, 2010 </a:t>
            </a:r>
          </a:p>
        </p:txBody>
      </p:sp>
    </p:spTree>
    <p:extLst>
      <p:ext uri="{BB962C8B-B14F-4D97-AF65-F5344CB8AC3E}">
        <p14:creationId xmlns:p14="http://schemas.microsoft.com/office/powerpoint/2010/main" val="3800161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0306291"/>
              </p:ext>
            </p:extLst>
          </p:nvPr>
        </p:nvGraphicFramePr>
        <p:xfrm>
          <a:off x="48086" y="1206202"/>
          <a:ext cx="9809825" cy="2005965"/>
        </p:xfrm>
        <a:graphic>
          <a:graphicData uri="http://schemas.openxmlformats.org/drawingml/2006/table">
            <a:tbl>
              <a:tblPr/>
              <a:tblGrid>
                <a:gridCol w="229049">
                  <a:extLst>
                    <a:ext uri="{9D8B030D-6E8A-4147-A177-3AD203B41FA5}">
                      <a16:colId xmlns:a16="http://schemas.microsoft.com/office/drawing/2014/main" val="3551098693"/>
                    </a:ext>
                  </a:extLst>
                </a:gridCol>
                <a:gridCol w="2381837">
                  <a:extLst>
                    <a:ext uri="{9D8B030D-6E8A-4147-A177-3AD203B41FA5}">
                      <a16:colId xmlns:a16="http://schemas.microsoft.com/office/drawing/2014/main" val="3931365132"/>
                    </a:ext>
                  </a:extLst>
                </a:gridCol>
                <a:gridCol w="2128430">
                  <a:extLst>
                    <a:ext uri="{9D8B030D-6E8A-4147-A177-3AD203B41FA5}">
                      <a16:colId xmlns:a16="http://schemas.microsoft.com/office/drawing/2014/main" val="1501634811"/>
                    </a:ext>
                  </a:extLst>
                </a:gridCol>
                <a:gridCol w="2258041">
                  <a:extLst>
                    <a:ext uri="{9D8B030D-6E8A-4147-A177-3AD203B41FA5}">
                      <a16:colId xmlns:a16="http://schemas.microsoft.com/office/drawing/2014/main" val="820040026"/>
                    </a:ext>
                  </a:extLst>
                </a:gridCol>
                <a:gridCol w="2812468">
                  <a:extLst>
                    <a:ext uri="{9D8B030D-6E8A-4147-A177-3AD203B41FA5}">
                      <a16:colId xmlns:a16="http://schemas.microsoft.com/office/drawing/2014/main" val="140471071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57693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ate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-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hyl-D-glucosid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actonic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-</a:t>
                      </a:r>
                      <a:r>
                        <a:rPr lang="el-G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-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o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rgin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34348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ruvic acid methyl este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Xylo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aminic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Asparag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54594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ween 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-Erythrito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Hydroxybenzoic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Phenylalan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19377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ween 8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annito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-Hydroxybenzoic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Ser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08975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odextri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-Acetyl-D-glucosam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-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butyric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Threon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45919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ge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Glucosaminic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aconic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yl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-glutamic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74399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Cellobio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-1-phosphat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tobutyric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enylethylami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32686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Lacto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,L-</a:t>
                      </a:r>
                      <a:r>
                        <a:rPr lang="el-G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erol phosphat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-Malic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tresc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567294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6056563"/>
              </p:ext>
            </p:extLst>
          </p:nvPr>
        </p:nvGraphicFramePr>
        <p:xfrm>
          <a:off x="2243181" y="3645833"/>
          <a:ext cx="4631770" cy="1520190"/>
        </p:xfrm>
        <a:graphic>
          <a:graphicData uri="http://schemas.openxmlformats.org/drawingml/2006/table">
            <a:tbl>
              <a:tblPr/>
              <a:tblGrid>
                <a:gridCol w="2517284">
                  <a:extLst>
                    <a:ext uri="{9D8B030D-6E8A-4147-A177-3AD203B41FA5}">
                      <a16:colId xmlns:a16="http://schemas.microsoft.com/office/drawing/2014/main" val="3220307497"/>
                    </a:ext>
                  </a:extLst>
                </a:gridCol>
                <a:gridCol w="2114486">
                  <a:extLst>
                    <a:ext uri="{9D8B030D-6E8A-4147-A177-3AD203B41FA5}">
                      <a16:colId xmlns:a16="http://schemas.microsoft.com/office/drawing/2014/main" val="391776697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gen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25466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ohydrat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4381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ym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87210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oxylic and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tonic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94326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 acid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38396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es/amid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A0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0150054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5772230"/>
            <a:ext cx="9905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ure S2</a:t>
            </a:r>
            <a:r>
              <a:rPr lang="en-US" dirty="0"/>
              <a:t>. Categorization of 95 carbon sources in </a:t>
            </a:r>
            <a:r>
              <a:rPr lang="en-US" dirty="0" err="1"/>
              <a:t>EcoPlate</a:t>
            </a:r>
            <a:r>
              <a:rPr lang="en-US" dirty="0"/>
              <a:t>™.</a:t>
            </a:r>
          </a:p>
        </p:txBody>
      </p:sp>
    </p:spTree>
    <p:extLst>
      <p:ext uri="{BB962C8B-B14F-4D97-AF65-F5344CB8AC3E}">
        <p14:creationId xmlns:p14="http://schemas.microsoft.com/office/powerpoint/2010/main" val="1665072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 rot="16200000">
            <a:off x="1786545" y="2443503"/>
            <a:ext cx="2203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Activity</a:t>
            </a:r>
            <a:r>
              <a:rPr lang="en-US" sz="969" dirty="0"/>
              <a:t>*</a:t>
            </a:r>
            <a:r>
              <a:rPr lang="en-US" sz="831" dirty="0"/>
              <a:t> of strains associated </a:t>
            </a:r>
          </a:p>
          <a:p>
            <a:pPr algn="ctr"/>
            <a:r>
              <a:rPr lang="en-US" sz="831" dirty="0"/>
              <a:t>with </a:t>
            </a:r>
            <a:r>
              <a:rPr lang="en-US" sz="831" i="1" dirty="0"/>
              <a:t>C. </a:t>
            </a:r>
            <a:r>
              <a:rPr lang="en-US" sz="831" i="1" dirty="0" err="1"/>
              <a:t>herbarum</a:t>
            </a:r>
            <a:r>
              <a:rPr lang="en-US" sz="831" i="1" dirty="0"/>
              <a:t> </a:t>
            </a:r>
            <a:r>
              <a:rPr lang="en-US" sz="831" dirty="0"/>
              <a:t>complex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02982" y="3524644"/>
            <a:ext cx="2353223" cy="348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Metabolic response of strains associated </a:t>
            </a:r>
          </a:p>
          <a:p>
            <a:pPr algn="ctr"/>
            <a:r>
              <a:rPr lang="en-US" sz="831" dirty="0"/>
              <a:t>with </a:t>
            </a:r>
            <a:r>
              <a:rPr lang="en-US" sz="831" i="1" dirty="0"/>
              <a:t>C. </a:t>
            </a:r>
            <a:r>
              <a:rPr lang="en-US" sz="831" i="1" dirty="0" err="1"/>
              <a:t>cladosporioides</a:t>
            </a:r>
            <a:r>
              <a:rPr lang="en-US" sz="831" i="1" dirty="0"/>
              <a:t> </a:t>
            </a:r>
            <a:r>
              <a:rPr lang="en-US" sz="831" dirty="0"/>
              <a:t>complex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246230" y="3536692"/>
            <a:ext cx="1793786" cy="348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Metabolic response of strains </a:t>
            </a:r>
          </a:p>
          <a:p>
            <a:pPr algn="ctr"/>
            <a:r>
              <a:rPr lang="en-US" sz="831" dirty="0"/>
              <a:t>associated with </a:t>
            </a:r>
            <a:r>
              <a:rPr lang="en-US" sz="831" i="1" dirty="0"/>
              <a:t>P. </a:t>
            </a:r>
            <a:r>
              <a:rPr lang="en-US" sz="831" i="1" dirty="0" err="1"/>
              <a:t>crustosum</a:t>
            </a:r>
            <a:endParaRPr lang="en-US" sz="831" i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4335952" y="2432548"/>
            <a:ext cx="1431802" cy="348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Activity of strains associated </a:t>
            </a:r>
          </a:p>
          <a:p>
            <a:pPr algn="ctr"/>
            <a:r>
              <a:rPr lang="en-US" sz="831" dirty="0"/>
              <a:t>with </a:t>
            </a:r>
            <a:r>
              <a:rPr lang="en-US" sz="831" i="1" dirty="0"/>
              <a:t>P. </a:t>
            </a:r>
            <a:r>
              <a:rPr lang="en-US" sz="831" i="1" dirty="0" err="1"/>
              <a:t>brevicompactum</a:t>
            </a:r>
            <a:endParaRPr lang="en-US" sz="831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2710127" y="5658127"/>
            <a:ext cx="246794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Metabolic response of </a:t>
            </a:r>
            <a:r>
              <a:rPr lang="en-US" sz="831" i="1" dirty="0"/>
              <a:t>Penicillium</a:t>
            </a:r>
            <a:r>
              <a:rPr lang="en-US" sz="831" dirty="0"/>
              <a:t> spp. strains</a:t>
            </a:r>
            <a:endParaRPr lang="en-US" sz="831" i="1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101720" y="4501279"/>
            <a:ext cx="1651999" cy="348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Activity of</a:t>
            </a:r>
          </a:p>
          <a:p>
            <a:pPr algn="ctr"/>
            <a:r>
              <a:rPr lang="en-US" sz="831" i="1" dirty="0"/>
              <a:t>Cladosporium </a:t>
            </a:r>
            <a:r>
              <a:rPr lang="en-US" sz="831" dirty="0"/>
              <a:t>spp. strains</a:t>
            </a:r>
          </a:p>
        </p:txBody>
      </p:sp>
      <p:sp>
        <p:nvSpPr>
          <p:cNvPr id="3" name="Oval 2"/>
          <p:cNvSpPr/>
          <p:nvPr/>
        </p:nvSpPr>
        <p:spPr>
          <a:xfrm>
            <a:off x="5657665" y="3939746"/>
            <a:ext cx="75588" cy="75588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0" name="Oval 29"/>
          <p:cNvSpPr/>
          <p:nvPr/>
        </p:nvSpPr>
        <p:spPr>
          <a:xfrm>
            <a:off x="5657665" y="4043140"/>
            <a:ext cx="75588" cy="75588"/>
          </a:xfrm>
          <a:prstGeom prst="ellipse">
            <a:avLst/>
          </a:prstGeom>
          <a:solidFill>
            <a:srgbClr val="F8981D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1" name="Oval 30"/>
          <p:cNvSpPr/>
          <p:nvPr/>
        </p:nvSpPr>
        <p:spPr>
          <a:xfrm>
            <a:off x="5657665" y="4146534"/>
            <a:ext cx="75588" cy="75588"/>
          </a:xfrm>
          <a:prstGeom prst="ellipse">
            <a:avLst/>
          </a:prstGeom>
          <a:solidFill>
            <a:srgbClr val="00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2" name="Oval 31"/>
          <p:cNvSpPr/>
          <p:nvPr/>
        </p:nvSpPr>
        <p:spPr>
          <a:xfrm>
            <a:off x="5663571" y="4251216"/>
            <a:ext cx="75588" cy="75588"/>
          </a:xfrm>
          <a:prstGeom prst="ellipse">
            <a:avLst/>
          </a:prstGeom>
          <a:solidFill>
            <a:srgbClr val="FBF87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3" name="Oval 32"/>
          <p:cNvSpPr/>
          <p:nvPr/>
        </p:nvSpPr>
        <p:spPr>
          <a:xfrm>
            <a:off x="5663571" y="4352359"/>
            <a:ext cx="75588" cy="75588"/>
          </a:xfrm>
          <a:prstGeom prst="ellipse">
            <a:avLst/>
          </a:prstGeom>
          <a:solidFill>
            <a:srgbClr val="BB3F7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4" name="Isosceles Triangle 3"/>
          <p:cNvSpPr/>
          <p:nvPr/>
        </p:nvSpPr>
        <p:spPr>
          <a:xfrm>
            <a:off x="5671575" y="4462312"/>
            <a:ext cx="75588" cy="85036"/>
          </a:xfrm>
          <a:prstGeom prst="triangl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4" name="Isosceles Triangle 33"/>
          <p:cNvSpPr/>
          <p:nvPr/>
        </p:nvSpPr>
        <p:spPr>
          <a:xfrm>
            <a:off x="5671575" y="4577848"/>
            <a:ext cx="75588" cy="85036"/>
          </a:xfrm>
          <a:prstGeom prst="triangle">
            <a:avLst/>
          </a:prstGeom>
          <a:solidFill>
            <a:srgbClr val="F8981D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5" name="Isosceles Triangle 34"/>
          <p:cNvSpPr/>
          <p:nvPr/>
        </p:nvSpPr>
        <p:spPr>
          <a:xfrm>
            <a:off x="5671575" y="4709546"/>
            <a:ext cx="75588" cy="85036"/>
          </a:xfrm>
          <a:prstGeom prst="triangle">
            <a:avLst/>
          </a:prstGeom>
          <a:solidFill>
            <a:srgbClr val="00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6" name="Isosceles Triangle 35"/>
          <p:cNvSpPr/>
          <p:nvPr/>
        </p:nvSpPr>
        <p:spPr>
          <a:xfrm>
            <a:off x="5671575" y="4824965"/>
            <a:ext cx="75588" cy="85036"/>
          </a:xfrm>
          <a:prstGeom prst="triangle">
            <a:avLst/>
          </a:prstGeom>
          <a:solidFill>
            <a:srgbClr val="FBF87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7" name="Isosceles Triangle 36"/>
          <p:cNvSpPr/>
          <p:nvPr/>
        </p:nvSpPr>
        <p:spPr>
          <a:xfrm>
            <a:off x="5671575" y="4940502"/>
            <a:ext cx="75588" cy="85036"/>
          </a:xfrm>
          <a:prstGeom prst="triangle">
            <a:avLst/>
          </a:prstGeom>
          <a:solidFill>
            <a:srgbClr val="BB3F7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5" name="Rectangle 4"/>
          <p:cNvSpPr/>
          <p:nvPr/>
        </p:nvSpPr>
        <p:spPr>
          <a:xfrm>
            <a:off x="5670295" y="5070055"/>
            <a:ext cx="80312" cy="85036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39" name="Rectangle 38"/>
          <p:cNvSpPr/>
          <p:nvPr/>
        </p:nvSpPr>
        <p:spPr>
          <a:xfrm>
            <a:off x="5670295" y="5187372"/>
            <a:ext cx="80312" cy="85036"/>
          </a:xfrm>
          <a:prstGeom prst="rect">
            <a:avLst/>
          </a:prstGeom>
          <a:solidFill>
            <a:srgbClr val="F8981D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40" name="Rectangle 39"/>
          <p:cNvSpPr/>
          <p:nvPr/>
        </p:nvSpPr>
        <p:spPr>
          <a:xfrm>
            <a:off x="5670295" y="5306693"/>
            <a:ext cx="80312" cy="85036"/>
          </a:xfrm>
          <a:prstGeom prst="rect">
            <a:avLst/>
          </a:prstGeom>
          <a:solidFill>
            <a:srgbClr val="00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41" name="Rectangle 40"/>
          <p:cNvSpPr/>
          <p:nvPr/>
        </p:nvSpPr>
        <p:spPr>
          <a:xfrm>
            <a:off x="5670295" y="5430583"/>
            <a:ext cx="80312" cy="85036"/>
          </a:xfrm>
          <a:prstGeom prst="rect">
            <a:avLst/>
          </a:prstGeom>
          <a:solidFill>
            <a:srgbClr val="FBF87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42" name="Rectangle 41"/>
          <p:cNvSpPr/>
          <p:nvPr/>
        </p:nvSpPr>
        <p:spPr>
          <a:xfrm>
            <a:off x="5671575" y="5543270"/>
            <a:ext cx="80312" cy="85036"/>
          </a:xfrm>
          <a:prstGeom prst="rect">
            <a:avLst/>
          </a:prstGeom>
          <a:solidFill>
            <a:srgbClr val="BB3F7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43" name="TextBox 42"/>
          <p:cNvSpPr txBox="1"/>
          <p:nvPr/>
        </p:nvSpPr>
        <p:spPr>
          <a:xfrm>
            <a:off x="5701365" y="3889317"/>
            <a:ext cx="631904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dirty="0"/>
              <a:t>Others (10)</a:t>
            </a:r>
            <a:endParaRPr lang="en-US" sz="762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5701365" y="3994066"/>
            <a:ext cx="965329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dirty="0"/>
              <a:t>Polysaccharides (6)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701364" y="4093771"/>
            <a:ext cx="1111202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Heterocyclic amines (4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701365" y="4198039"/>
            <a:ext cx="790601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dirty="0"/>
              <a:t>Glucosides (11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701365" y="4297653"/>
            <a:ext cx="595035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dirty="0"/>
              <a:t>Polyols (9)</a:t>
            </a:r>
          </a:p>
        </p:txBody>
      </p:sp>
      <p:sp>
        <p:nvSpPr>
          <p:cNvPr id="47" name="Rectangle 46"/>
          <p:cNvSpPr/>
          <p:nvPr/>
        </p:nvSpPr>
        <p:spPr>
          <a:xfrm>
            <a:off x="5715275" y="4414053"/>
            <a:ext cx="1176925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Aliphatic organic acids(4)</a:t>
            </a:r>
          </a:p>
        </p:txBody>
      </p:sp>
      <p:sp>
        <p:nvSpPr>
          <p:cNvPr id="48" name="Rectangle 47"/>
          <p:cNvSpPr/>
          <p:nvPr/>
        </p:nvSpPr>
        <p:spPr>
          <a:xfrm>
            <a:off x="5715275" y="4531557"/>
            <a:ext cx="846707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Amino acids (12)</a:t>
            </a:r>
          </a:p>
        </p:txBody>
      </p:sp>
      <p:sp>
        <p:nvSpPr>
          <p:cNvPr id="49" name="Rectangle 48"/>
          <p:cNvSpPr/>
          <p:nvPr/>
        </p:nvSpPr>
        <p:spPr>
          <a:xfrm>
            <a:off x="5718103" y="4664957"/>
            <a:ext cx="1276311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TCA-cycle intermediates (5)</a:t>
            </a:r>
          </a:p>
        </p:txBody>
      </p:sp>
      <p:sp>
        <p:nvSpPr>
          <p:cNvPr id="50" name="Rectangle 49"/>
          <p:cNvSpPr/>
          <p:nvPr/>
        </p:nvSpPr>
        <p:spPr>
          <a:xfrm>
            <a:off x="5707793" y="4777198"/>
            <a:ext cx="760144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Sugar acids (6)</a:t>
            </a:r>
          </a:p>
        </p:txBody>
      </p:sp>
      <p:sp>
        <p:nvSpPr>
          <p:cNvPr id="51" name="Rectangle 50"/>
          <p:cNvSpPr/>
          <p:nvPr/>
        </p:nvSpPr>
        <p:spPr>
          <a:xfrm>
            <a:off x="5713253" y="4901368"/>
            <a:ext cx="644728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 err="1"/>
              <a:t>Heptose</a:t>
            </a:r>
            <a:r>
              <a:rPr lang="en-US" sz="762" dirty="0"/>
              <a:t> (1)</a:t>
            </a:r>
          </a:p>
        </p:txBody>
      </p:sp>
      <p:sp>
        <p:nvSpPr>
          <p:cNvPr id="52" name="Rectangle 51"/>
          <p:cNvSpPr/>
          <p:nvPr/>
        </p:nvSpPr>
        <p:spPr>
          <a:xfrm>
            <a:off x="5713253" y="5018566"/>
            <a:ext cx="1031051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Oligosaccharides (10)</a:t>
            </a:r>
          </a:p>
        </p:txBody>
      </p:sp>
      <p:sp>
        <p:nvSpPr>
          <p:cNvPr id="53" name="Rectangle 52"/>
          <p:cNvSpPr/>
          <p:nvPr/>
        </p:nvSpPr>
        <p:spPr>
          <a:xfrm>
            <a:off x="5713253" y="5137778"/>
            <a:ext cx="792205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 err="1"/>
              <a:t>Hexosamins</a:t>
            </a:r>
            <a:r>
              <a:rPr lang="en-US" sz="762" dirty="0"/>
              <a:t> (4)</a:t>
            </a:r>
          </a:p>
        </p:txBody>
      </p:sp>
      <p:sp>
        <p:nvSpPr>
          <p:cNvPr id="54" name="Rectangle 53"/>
          <p:cNvSpPr/>
          <p:nvPr/>
        </p:nvSpPr>
        <p:spPr>
          <a:xfrm>
            <a:off x="5713253" y="5258994"/>
            <a:ext cx="641522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Hexoses (8)</a:t>
            </a:r>
          </a:p>
        </p:txBody>
      </p:sp>
      <p:sp>
        <p:nvSpPr>
          <p:cNvPr id="55" name="Rectangle 54"/>
          <p:cNvSpPr/>
          <p:nvPr/>
        </p:nvSpPr>
        <p:spPr>
          <a:xfrm>
            <a:off x="5714035" y="5375479"/>
            <a:ext cx="671979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 err="1"/>
              <a:t>Pentoses</a:t>
            </a:r>
            <a:r>
              <a:rPr lang="en-US" sz="762" dirty="0"/>
              <a:t> (4)</a:t>
            </a:r>
          </a:p>
        </p:txBody>
      </p:sp>
      <p:sp>
        <p:nvSpPr>
          <p:cNvPr id="56" name="Rectangle 55"/>
          <p:cNvSpPr/>
          <p:nvPr/>
        </p:nvSpPr>
        <p:spPr>
          <a:xfrm>
            <a:off x="5713253" y="5501956"/>
            <a:ext cx="655949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62" dirty="0"/>
              <a:t>Peptides (3)</a:t>
            </a:r>
          </a:p>
        </p:txBody>
      </p:sp>
      <p:sp>
        <p:nvSpPr>
          <p:cNvPr id="57" name="Rectangle 56"/>
          <p:cNvSpPr/>
          <p:nvPr/>
        </p:nvSpPr>
        <p:spPr>
          <a:xfrm>
            <a:off x="5594501" y="3831318"/>
            <a:ext cx="1343463" cy="1898884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8406" y="1697466"/>
            <a:ext cx="1822374" cy="1861404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4611415" y="3223149"/>
            <a:ext cx="28084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/>
              <a:t>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0776" y="1696784"/>
            <a:ext cx="1849240" cy="1895242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6755870" y="3219873"/>
            <a:ext cx="27443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/>
              <a:t>B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72064" y="3831029"/>
            <a:ext cx="1818244" cy="1869673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4623623" y="5338190"/>
            <a:ext cx="26962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/>
              <a:t>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7502FDD-81BE-4989-AB95-1FB7B1A066E7}"/>
              </a:ext>
            </a:extLst>
          </p:cNvPr>
          <p:cNvSpPr txBox="1"/>
          <p:nvPr/>
        </p:nvSpPr>
        <p:spPr>
          <a:xfrm>
            <a:off x="2579077" y="145655"/>
            <a:ext cx="4747846" cy="4331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215" b="1" dirty="0"/>
              <a:t>Figure S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628AF74-FFE2-4D91-A05F-16BABE81818E}"/>
              </a:ext>
            </a:extLst>
          </p:cNvPr>
          <p:cNvSpPr txBox="1"/>
          <p:nvPr/>
        </p:nvSpPr>
        <p:spPr>
          <a:xfrm>
            <a:off x="2710127" y="625543"/>
            <a:ext cx="4543058" cy="8592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46" dirty="0"/>
              <a:t>Scatter plots of activity for </a:t>
            </a:r>
            <a:r>
              <a:rPr lang="en-US" sz="1246" i="1" dirty="0"/>
              <a:t>Cladosporium</a:t>
            </a:r>
            <a:r>
              <a:rPr lang="en-US" sz="1246" dirty="0"/>
              <a:t> spp. strains (A), </a:t>
            </a:r>
            <a:r>
              <a:rPr lang="en-US" sz="1246" i="1" dirty="0"/>
              <a:t>Penicillium</a:t>
            </a:r>
            <a:r>
              <a:rPr lang="en-US" sz="1246" dirty="0"/>
              <a:t> spp. strains (B), and both genera (C) (*=Optical density (OD) of carbon source wells inoculated with strains - OD of the control well at 490 nm). </a:t>
            </a:r>
          </a:p>
        </p:txBody>
      </p:sp>
    </p:spTree>
    <p:extLst>
      <p:ext uri="{BB962C8B-B14F-4D97-AF65-F5344CB8AC3E}">
        <p14:creationId xmlns:p14="http://schemas.microsoft.com/office/powerpoint/2010/main" val="41406474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161C347-74D7-4BBF-87AD-300E7F09E4C6}"/>
              </a:ext>
            </a:extLst>
          </p:cNvPr>
          <p:cNvSpPr txBox="1"/>
          <p:nvPr/>
        </p:nvSpPr>
        <p:spPr>
          <a:xfrm rot="16200000">
            <a:off x="4019810" y="2479464"/>
            <a:ext cx="1459715" cy="4759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Activity of</a:t>
            </a:r>
          </a:p>
          <a:p>
            <a:pPr algn="ctr"/>
            <a:r>
              <a:rPr lang="en-US" sz="831" dirty="0"/>
              <a:t>of all </a:t>
            </a:r>
            <a:r>
              <a:rPr lang="en-US" sz="831" i="1" dirty="0" err="1"/>
              <a:t>Saprolegniales</a:t>
            </a:r>
            <a:r>
              <a:rPr lang="en-US" sz="831" dirty="0"/>
              <a:t> strains</a:t>
            </a:r>
          </a:p>
          <a:p>
            <a:pPr algn="ctr"/>
            <a:endParaRPr lang="en-US" sz="831" i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F9DF9D-BCB6-4DB8-85F6-D151ED463C8C}"/>
              </a:ext>
            </a:extLst>
          </p:cNvPr>
          <p:cNvSpPr txBox="1"/>
          <p:nvPr/>
        </p:nvSpPr>
        <p:spPr>
          <a:xfrm>
            <a:off x="5064741" y="3459888"/>
            <a:ext cx="1132463" cy="348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Metabolic response all fungal strains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7242894E-048F-4574-911D-3CDE74D7529D}"/>
              </a:ext>
            </a:extLst>
          </p:cNvPr>
          <p:cNvSpPr/>
          <p:nvPr/>
        </p:nvSpPr>
        <p:spPr>
          <a:xfrm>
            <a:off x="6308892" y="2278335"/>
            <a:ext cx="101226" cy="104310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CC2A39D5-3C27-4FEC-908E-3B895CBF9DE4}"/>
              </a:ext>
            </a:extLst>
          </p:cNvPr>
          <p:cNvSpPr/>
          <p:nvPr/>
        </p:nvSpPr>
        <p:spPr>
          <a:xfrm>
            <a:off x="6308892" y="2417124"/>
            <a:ext cx="101226" cy="104310"/>
          </a:xfrm>
          <a:prstGeom prst="ellipse">
            <a:avLst/>
          </a:prstGeom>
          <a:solidFill>
            <a:srgbClr val="F8981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1EC22353-5614-4BE8-82D3-5A10F70879EC}"/>
              </a:ext>
            </a:extLst>
          </p:cNvPr>
          <p:cNvSpPr/>
          <p:nvPr/>
        </p:nvSpPr>
        <p:spPr>
          <a:xfrm>
            <a:off x="6308892" y="2631814"/>
            <a:ext cx="101226" cy="104310"/>
          </a:xfrm>
          <a:prstGeom prst="ellipse">
            <a:avLst/>
          </a:prstGeom>
          <a:solidFill>
            <a:srgbClr val="2EB84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D953C312-7562-4C5C-BEA0-35C31E269C1F}"/>
              </a:ext>
            </a:extLst>
          </p:cNvPr>
          <p:cNvSpPr/>
          <p:nvPr/>
        </p:nvSpPr>
        <p:spPr>
          <a:xfrm>
            <a:off x="6308892" y="2769246"/>
            <a:ext cx="101226" cy="104310"/>
          </a:xfrm>
          <a:prstGeom prst="ellipse">
            <a:avLst/>
          </a:prstGeom>
          <a:solidFill>
            <a:srgbClr val="BB3F7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661CFF23-6ECD-4062-A8DC-F61FF9FD122F}"/>
              </a:ext>
            </a:extLst>
          </p:cNvPr>
          <p:cNvSpPr/>
          <p:nvPr/>
        </p:nvSpPr>
        <p:spPr>
          <a:xfrm>
            <a:off x="6308892" y="2906678"/>
            <a:ext cx="101226" cy="104310"/>
          </a:xfrm>
          <a:prstGeom prst="ellipse">
            <a:avLst/>
          </a:prstGeom>
          <a:solidFill>
            <a:srgbClr val="48C2C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B9D04E6-C819-4A7D-B4F0-AB092311F9B5}"/>
              </a:ext>
            </a:extLst>
          </p:cNvPr>
          <p:cNvSpPr txBox="1"/>
          <p:nvPr/>
        </p:nvSpPr>
        <p:spPr>
          <a:xfrm>
            <a:off x="6348905" y="2228974"/>
            <a:ext cx="914033" cy="2042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27" dirty="0"/>
              <a:t>Carbohydrates (10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C0EFE3-91C2-4642-B2B0-760FB39ECF94}"/>
              </a:ext>
            </a:extLst>
          </p:cNvPr>
          <p:cNvSpPr txBox="1"/>
          <p:nvPr/>
        </p:nvSpPr>
        <p:spPr>
          <a:xfrm>
            <a:off x="6386900" y="2394750"/>
            <a:ext cx="896399" cy="272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92"/>
              </a:lnSpc>
            </a:pPr>
            <a:r>
              <a:rPr lang="en-US" sz="692" dirty="0"/>
              <a:t>Carboxylic </a:t>
            </a:r>
          </a:p>
          <a:p>
            <a:pPr>
              <a:lnSpc>
                <a:spcPts val="692"/>
              </a:lnSpc>
            </a:pPr>
            <a:r>
              <a:rPr lang="en-US" sz="692" dirty="0"/>
              <a:t>and </a:t>
            </a:r>
            <a:r>
              <a:rPr lang="en-US" sz="692" dirty="0" err="1"/>
              <a:t>ketonic</a:t>
            </a:r>
            <a:r>
              <a:rPr lang="en-US" sz="692" dirty="0"/>
              <a:t> acid (9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D05948-3264-4B8B-855B-1993AEE4F1EA}"/>
              </a:ext>
            </a:extLst>
          </p:cNvPr>
          <p:cNvSpPr txBox="1"/>
          <p:nvPr/>
        </p:nvSpPr>
        <p:spPr>
          <a:xfrm>
            <a:off x="6353210" y="2596610"/>
            <a:ext cx="74411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92" dirty="0"/>
              <a:t>Amino acids (6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D6204A-B8DD-4733-8D47-35C69CDB6B7D}"/>
              </a:ext>
            </a:extLst>
          </p:cNvPr>
          <p:cNvSpPr txBox="1"/>
          <p:nvPr/>
        </p:nvSpPr>
        <p:spPr>
          <a:xfrm>
            <a:off x="6347487" y="2732945"/>
            <a:ext cx="869149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92" dirty="0"/>
              <a:t>Amines/amides (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2B8840-1A5E-4E19-9692-38E0905A6936}"/>
              </a:ext>
            </a:extLst>
          </p:cNvPr>
          <p:cNvSpPr txBox="1"/>
          <p:nvPr/>
        </p:nvSpPr>
        <p:spPr>
          <a:xfrm>
            <a:off x="6354814" y="2870940"/>
            <a:ext cx="639919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92" dirty="0"/>
              <a:t>Polymers (4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97B414-9C98-4718-821F-5B2D65E4366A}"/>
              </a:ext>
            </a:extLst>
          </p:cNvPr>
          <p:cNvSpPr txBox="1"/>
          <p:nvPr/>
        </p:nvSpPr>
        <p:spPr>
          <a:xfrm rot="16200000">
            <a:off x="2290395" y="2582404"/>
            <a:ext cx="1323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31" dirty="0"/>
              <a:t>Activity</a:t>
            </a:r>
            <a:r>
              <a:rPr lang="en-US" sz="969" dirty="0"/>
              <a:t>*</a:t>
            </a:r>
            <a:r>
              <a:rPr lang="en-US" sz="831" dirty="0"/>
              <a:t> of</a:t>
            </a:r>
          </a:p>
          <a:p>
            <a:pPr algn="ctr"/>
            <a:r>
              <a:rPr lang="en-US" sz="831" dirty="0"/>
              <a:t>of </a:t>
            </a:r>
            <a:r>
              <a:rPr lang="en-US" sz="831" i="1" dirty="0" err="1"/>
              <a:t>Achlya</a:t>
            </a:r>
            <a:r>
              <a:rPr lang="en-US" sz="831" i="1" dirty="0"/>
              <a:t> </a:t>
            </a:r>
            <a:r>
              <a:rPr lang="en-US" sz="831" dirty="0"/>
              <a:t>spp.</a:t>
            </a:r>
            <a:endParaRPr lang="en-US" sz="831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4C13C49-F9CC-468E-B1EF-5ADF4F1056AE}"/>
              </a:ext>
            </a:extLst>
          </p:cNvPr>
          <p:cNvSpPr txBox="1"/>
          <p:nvPr/>
        </p:nvSpPr>
        <p:spPr>
          <a:xfrm>
            <a:off x="3208262" y="3459888"/>
            <a:ext cx="1175322" cy="348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Metabolic response of </a:t>
            </a:r>
          </a:p>
          <a:p>
            <a:pPr algn="ctr"/>
            <a:r>
              <a:rPr lang="en-US" sz="831" i="1" dirty="0" err="1"/>
              <a:t>Dictyuchus</a:t>
            </a:r>
            <a:r>
              <a:rPr lang="en-US" sz="831" i="1" dirty="0"/>
              <a:t> </a:t>
            </a:r>
            <a:r>
              <a:rPr lang="en-US" sz="831" dirty="0"/>
              <a:t>spp.</a:t>
            </a:r>
            <a:endParaRPr lang="en-US" sz="831" i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98D623C-300A-4150-823D-846BD24914DA}"/>
              </a:ext>
            </a:extLst>
          </p:cNvPr>
          <p:cNvSpPr txBox="1"/>
          <p:nvPr/>
        </p:nvSpPr>
        <p:spPr>
          <a:xfrm>
            <a:off x="2718228" y="3337125"/>
            <a:ext cx="28084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F6B09A-2AF7-4F7C-AF42-484A388572FC}"/>
              </a:ext>
            </a:extLst>
          </p:cNvPr>
          <p:cNvSpPr txBox="1"/>
          <p:nvPr/>
        </p:nvSpPr>
        <p:spPr>
          <a:xfrm>
            <a:off x="4557602" y="3337125"/>
            <a:ext cx="27443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/>
              <a:t>B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116EE8F9-A7A6-4E29-BC08-FACFE9F5FC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4075" y="1997570"/>
            <a:ext cx="1426641" cy="146231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41B2E5F-A404-4C9D-86E4-D3F638826B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53838" y="1997570"/>
            <a:ext cx="1428891" cy="1462319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9F13EC7-ACD9-413A-83DD-9AC2CD3EE79A}"/>
              </a:ext>
            </a:extLst>
          </p:cNvPr>
          <p:cNvSpPr txBox="1"/>
          <p:nvPr/>
        </p:nvSpPr>
        <p:spPr>
          <a:xfrm>
            <a:off x="2579077" y="145655"/>
            <a:ext cx="4747846" cy="4331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215" b="1" dirty="0"/>
              <a:t>Figure S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A85758D-94E1-47A2-A682-1C79971A119A}"/>
              </a:ext>
            </a:extLst>
          </p:cNvPr>
          <p:cNvSpPr txBox="1"/>
          <p:nvPr/>
        </p:nvSpPr>
        <p:spPr>
          <a:xfrm>
            <a:off x="2638426" y="828875"/>
            <a:ext cx="4688497" cy="9448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85" dirty="0"/>
              <a:t>Scatter plots of activity for </a:t>
            </a:r>
            <a:r>
              <a:rPr lang="en-US" sz="1385" i="1" dirty="0" err="1"/>
              <a:t>Achlya</a:t>
            </a:r>
            <a:r>
              <a:rPr lang="en-US" sz="1385" dirty="0"/>
              <a:t> vs. </a:t>
            </a:r>
            <a:r>
              <a:rPr lang="en-US" sz="1385" i="1" dirty="0" err="1"/>
              <a:t>Dictyuchus</a:t>
            </a:r>
            <a:r>
              <a:rPr lang="en-US" sz="1385" dirty="0"/>
              <a:t> strains (A) and </a:t>
            </a:r>
            <a:r>
              <a:rPr lang="en-US" sz="1385" dirty="0" err="1"/>
              <a:t>Saprolegniales</a:t>
            </a:r>
            <a:r>
              <a:rPr lang="en-US" sz="1385" dirty="0"/>
              <a:t> vs. fungal strains (B) (*=Optical density (OD) of carbon source wells inoculated with strains - OD of the control well at 490 nm). </a:t>
            </a:r>
          </a:p>
        </p:txBody>
      </p:sp>
    </p:spTree>
    <p:extLst>
      <p:ext uri="{BB962C8B-B14F-4D97-AF65-F5344CB8AC3E}">
        <p14:creationId xmlns:p14="http://schemas.microsoft.com/office/powerpoint/2010/main" val="2615044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1</TotalTime>
  <Words>591</Words>
  <Application>Microsoft Office PowerPoint</Application>
  <PresentationFormat>A4 Paper (210x297 mm)</PresentationFormat>
  <Paragraphs>25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doftech</dc:creator>
  <cp:lastModifiedBy>Lenovo</cp:lastModifiedBy>
  <cp:revision>79</cp:revision>
  <dcterms:created xsi:type="dcterms:W3CDTF">2021-12-27T08:22:04Z</dcterms:created>
  <dcterms:modified xsi:type="dcterms:W3CDTF">2023-01-17T08:45:58Z</dcterms:modified>
</cp:coreProperties>
</file>